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1405" r:id="rId2"/>
    <p:sldId id="1390" r:id="rId3"/>
    <p:sldId id="1399" r:id="rId4"/>
    <p:sldId id="288" r:id="rId5"/>
  </p:sldIdLst>
  <p:sldSz cx="12192000" cy="6858000"/>
  <p:notesSz cx="6805613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Figure" id="{9C9A8FA0-19D9-4168-97D4-01163FFC6703}">
          <p14:sldIdLst>
            <p14:sldId id="1405"/>
            <p14:sldId id="1390"/>
            <p14:sldId id="1399"/>
            <p14:sldId id="28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FF"/>
    <a:srgbClr val="000000"/>
    <a:srgbClr val="0054D0"/>
    <a:srgbClr val="A6A6A6"/>
    <a:srgbClr val="CC99FF"/>
    <a:srgbClr val="2F2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84" autoAdjust="0"/>
    <p:restoredTop sz="88791" autoAdjust="0"/>
  </p:normalViewPr>
  <p:slideViewPr>
    <p:cSldViewPr snapToGrid="0">
      <p:cViewPr varScale="1">
        <p:scale>
          <a:sx n="162" d="100"/>
          <a:sy n="162" d="100"/>
        </p:scale>
        <p:origin x="292" y="108"/>
      </p:cViewPr>
      <p:guideLst>
        <p:guide orient="horz" pos="2183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549117-E0D9-46DD-86EC-BB844428CE63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1063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562" y="4783307"/>
            <a:ext cx="544449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8EEDA5-AEB7-4FD1-9A4D-8A57CE15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4079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 altLang="ko-KR" b="0" i="0" dirty="0">
              <a:solidFill>
                <a:srgbClr val="111111"/>
              </a:solidFill>
              <a:effectLst/>
              <a:latin typeface="Roboto" panose="020B0604020202020204" pitchFamily="2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EEDA5-AEB7-4FD1-9A4D-8A57CE15E2B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28198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98EEDA5-AEB7-4FD1-9A4D-8A57CE15E2B7}" type="slidenum">
              <a:rPr kumimoji="0" lang="ko-KR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ko-KR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400771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EEDA5-AEB7-4FD1-9A4D-8A57CE15E2B7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4845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5297FB4-9365-4581-9902-126B7974D0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730FC55-84B5-4C00-A3F5-AD450B72C3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375CCE6-A516-4C98-BB76-9951D1EF3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CBEA70-0C34-4F4C-AFD4-4CE4391A3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BF859F-3CFE-4A19-B2C9-D03D84E96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8845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BA7C5B-4C69-4F79-BA13-FF0392FDF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D569703-1A69-4EB6-9755-DFF1D4E06A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FB35723-4BC7-4FF4-8D47-5E2F72C0B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39FB26-C37B-412B-A4C0-45064AD4E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14D2D8-A67C-43CA-87E4-767A80735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0179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A872CB0-784D-4C2B-9FD7-457BD40BBA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31D084C-CDF5-44A5-814D-4CE3DE1CEA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D77FEB3-A955-406F-99E3-D56991E82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9AB84BE-4303-43B6-B17D-AC997A5FF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7937EB7-E2CC-4B11-9B8D-4B42AB223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217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09A4E6-6D25-48FB-9BA4-3BB2B5422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CC17725-5541-4009-9A4A-97CB3561E1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3034FA-2C22-421C-9808-934C55EAD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FDD429-1EE4-4D02-A178-E48556E52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2943D37-7048-4422-8D5B-05E606F6C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4239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4ED532-334F-4385-8CE8-212C34852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256483A-9CA8-4B3F-98F2-10357F7969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E0A945B-C432-44A8-BAD8-77D76783B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9CF6D9-D38D-49FC-867A-59BA254A6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BE41C7B-0091-4E59-9BFC-49F3EEE5B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8516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8BAE95-6D53-4BD5-8659-3CA435C2B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95072F3-7259-4CAD-9049-F5AB6310FE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B3087D2-84CF-4626-8383-0CC93C639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C91DB37-B926-465E-9654-F63B6C822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8324C63-EA94-45EE-96D2-ECEE8F8DC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7A2F1C5-B9F0-46C6-832A-A23DDD623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1007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369EE4-9C68-4CDF-B652-CA14CADCB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5850F4F-28B9-4789-B696-C3B3E87898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927E5E3-84E2-4F05-8B95-85332E44A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D1169E1-B968-4B92-BAAE-A56A772011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8CD500F-762E-481A-86FA-C7E27E0B6A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0BEBF0C-D0A2-4869-AAEF-94D92BC4B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4282A15-C380-49A7-BB3E-ECDB4E197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80D708B-93AF-48E4-995A-ED0BBE000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8021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0534AA0-DE00-4FB1-A3DC-10967F8122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1D6DAE0-0220-4F19-85D1-C6EA2F652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E7537E7-FFC3-4604-A14F-87B85BD63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A8FD1C2-9FE0-4801-8F87-546CA6C73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3763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BE848A1-FF42-4E08-9E52-390BE118B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7AB0E95-D002-4E40-92ED-31D5745BF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3B6CBCA-67A8-46A3-BCCA-BBF06D3C7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31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7AB875-E62D-4349-B497-0BE1AC892D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63BD3EF-7569-415D-BAE6-C247EA7544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15B6576-5E42-4891-8B3A-E7A9F3C870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7671471-08AD-49BF-AECE-47AFE6920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4D82A37-C1C5-431B-8148-DE0976662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E7FF76D-E634-4731-A234-8A1A6C758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2733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4E3C91E-B1FA-446E-9C3B-37979B519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2D58C73-3094-4009-8833-FB84B94A9F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84C23A3-49D9-419B-8326-F212529EAB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C76B2F6-AAB0-4B69-9FBF-1331D1B74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291029E-DDF2-4B6A-8DD1-3AEA02A5C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5DC531A-2B0F-4D07-9FA8-E67DFC5AB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1721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26AA3AC-167D-41F5-A39D-1639BCE07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3ED887F-EB33-4E10-8350-F0C7AAA212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1D3AFD9-914C-44C7-AD10-5041B94853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68465-112D-41AD-9472-295CE3217CC7}" type="datetimeFigureOut">
              <a:rPr lang="ko-KR" altLang="en-US" smtClean="0"/>
              <a:t>2023-0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E489782-0F86-44B4-B963-59AFABC6D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0CEEB1-130B-4B00-8BB8-701C4A3D5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954E5-DD8C-4C8A-8E34-51037BFF54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062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9C76DD5-CB10-4919-ABFD-455DB90C975D}"/>
              </a:ext>
            </a:extLst>
          </p:cNvPr>
          <p:cNvSpPr txBox="1"/>
          <p:nvPr/>
        </p:nvSpPr>
        <p:spPr>
          <a:xfrm>
            <a:off x="1128000" y="5745214"/>
            <a:ext cx="9936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g strategy for the analysis of innate immune cell subsets. 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  <a:cs typeface="Times New Roman" panose="02020603050405020304" pitchFamily="18" charset="0"/>
              </a:rPr>
              <a:t>S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inglets were captured from all events based on FSC-A/FSC-H. Then, the debris with low SSC-H and FSC-H were excluded and the dead cells were stained with fixable viability dye to select live cells from total cell population. Dendritic cells were identified as CD11c</a:t>
            </a:r>
            <a:r>
              <a:rPr lang="en-US" altLang="ko-KR" sz="1200" baseline="300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hi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MHC-II</a:t>
            </a:r>
            <a:r>
              <a:rPr lang="en-US" altLang="ko-KR" sz="1200" baseline="300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hi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 cells, neu</a:t>
            </a:r>
            <a:r>
              <a:rPr lang="en-US" altLang="ko-KR" sz="1200" dirty="0">
                <a:latin typeface="Times New Roman" panose="02020603050405020304" pitchFamily="18" charset="0"/>
                <a:ea typeface="바탕체" panose="02030609000101010101" pitchFamily="17" charset="-127"/>
              </a:rPr>
              <a:t>trophils as CD11b</a:t>
            </a:r>
            <a:r>
              <a:rPr lang="en-US" altLang="ko-KR" sz="1200" baseline="30000" dirty="0">
                <a:latin typeface="Times New Roman" panose="02020603050405020304" pitchFamily="18" charset="0"/>
                <a:ea typeface="바탕체" panose="02030609000101010101" pitchFamily="17" charset="-127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바탕체" panose="02030609000101010101" pitchFamily="17" charset="-127"/>
              </a:rPr>
              <a:t>Ly6G</a:t>
            </a:r>
            <a:r>
              <a:rPr lang="en-US" altLang="ko-KR" sz="1200" baseline="30000" dirty="0">
                <a:latin typeface="Times New Roman" panose="02020603050405020304" pitchFamily="18" charset="0"/>
                <a:ea typeface="바탕체" panose="02030609000101010101" pitchFamily="17" charset="-127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바탕체" panose="02030609000101010101" pitchFamily="17" charset="-127"/>
              </a:rPr>
              <a:t> cells, and macrophages as CD11b</a:t>
            </a:r>
            <a:r>
              <a:rPr lang="en-US" altLang="ko-KR" sz="1200" baseline="30000" dirty="0">
                <a:latin typeface="Times New Roman" panose="02020603050405020304" pitchFamily="18" charset="0"/>
                <a:ea typeface="바탕체" panose="02030609000101010101" pitchFamily="17" charset="-127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바탕체" panose="02030609000101010101" pitchFamily="17" charset="-127"/>
              </a:rPr>
              <a:t>F4/80</a:t>
            </a:r>
            <a:r>
              <a:rPr lang="en-US" altLang="ko-KR" sz="1200" baseline="30000" dirty="0">
                <a:latin typeface="Times New Roman" panose="02020603050405020304" pitchFamily="18" charset="0"/>
                <a:ea typeface="바탕체" panose="02030609000101010101" pitchFamily="17" charset="-127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바탕체" panose="02030609000101010101" pitchFamily="17" charset="-127"/>
              </a:rPr>
              <a:t>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AA6ABE4-1313-4F0B-8862-4B93BF578C89}"/>
              </a:ext>
            </a:extLst>
          </p:cNvPr>
          <p:cNvSpPr txBox="1"/>
          <p:nvPr/>
        </p:nvSpPr>
        <p:spPr>
          <a:xfrm>
            <a:off x="0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0063" y="767580"/>
            <a:ext cx="7451872" cy="4433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601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BAA6ABE4-1313-4F0B-8862-4B93BF578C89}"/>
              </a:ext>
            </a:extLst>
          </p:cNvPr>
          <p:cNvSpPr txBox="1"/>
          <p:nvPr/>
        </p:nvSpPr>
        <p:spPr>
          <a:xfrm>
            <a:off x="0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5C70634-5FF4-4F1A-97BA-89462736B06C}"/>
              </a:ext>
            </a:extLst>
          </p:cNvPr>
          <p:cNvSpPr txBox="1"/>
          <p:nvPr/>
        </p:nvSpPr>
        <p:spPr>
          <a:xfrm>
            <a:off x="1128000" y="4737885"/>
            <a:ext cx="9936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  <a:r>
              <a:rPr lang="en-US" altLang="ko-KR" sz="1200" b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| 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ynthesis of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sRNAs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selection of a candidate as a novel adjuvant. (A) Since dsRNA activates TLR3 signaling, we investigated whether synthetic dsRNA could act as a TLR3 agonist. Human TLR3-expressing HEK 293 cells were stimulated with 10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/ml of the indicated dsRNA having a length of 319 to 508 bp and 50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/ml of poly(I:C) (positive control) for 24 h. The 20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culture supernatant was mixed with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Quanti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Blue (180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in a flat 96-well plate and incubated at 37℃ for 1-3 h, and the absorbance was measured at 655 nm. Response ratio ± S.D. was defined as OD of sample/OD of non-treated (NT) control. (B) BALB/c mice (n=3 or 4) were intramuscularly immunized twice with OVA alone or mixed with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sRNAs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319, 397, 466, or 508 bp in length. Two weeks after the second vaccination, OVA-specific total IgG level in serum was measured by ELISA. (*) indicates statistical significance at p &lt; 0.05 between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sRNAs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319 bp length and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sRNAs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other lengths. (C) Primers were designed for PCR reaction as a DNA template from 345 to 510 bp and the PCR products were used for dsRNA synthesis. The dsRNA samples were electrophoresed and visualized on 1% agarose gel. NT; non-treated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6822" y="993045"/>
            <a:ext cx="11138357" cy="315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4692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9C76DD5-CB10-4919-ABFD-455DB90C975D}"/>
              </a:ext>
            </a:extLst>
          </p:cNvPr>
          <p:cNvSpPr txBox="1"/>
          <p:nvPr/>
        </p:nvSpPr>
        <p:spPr>
          <a:xfrm>
            <a:off x="1128000" y="5548622"/>
            <a:ext cx="993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| Differential susceptibility of NVT to RNases. NVT was treated with RNase A, RNase III, or RNase III plu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se T1, and then subjected to 1% agarose gel electrophoresis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A6ABE4-1313-4F0B-8862-4B93BF578C89}"/>
              </a:ext>
            </a:extLst>
          </p:cNvPr>
          <p:cNvSpPr txBox="1"/>
          <p:nvPr/>
        </p:nvSpPr>
        <p:spPr>
          <a:xfrm>
            <a:off x="0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7177" y="1114925"/>
            <a:ext cx="2377646" cy="3718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89059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319422B-288F-4DC8-AAC4-07E0491E01A3}"/>
              </a:ext>
            </a:extLst>
          </p:cNvPr>
          <p:cNvSpPr txBox="1"/>
          <p:nvPr/>
        </p:nvSpPr>
        <p:spPr>
          <a:xfrm>
            <a:off x="0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9C76DD5-CB10-4919-ABFD-455DB90C975D}"/>
              </a:ext>
            </a:extLst>
          </p:cNvPr>
          <p:cNvSpPr txBox="1"/>
          <p:nvPr/>
        </p:nvSpPr>
        <p:spPr>
          <a:xfrm>
            <a:off x="1128000" y="5408445"/>
            <a:ext cx="9936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</a:t>
            </a:r>
            <a:r>
              <a:rPr lang="en-US" altLang="ko-KR" sz="1200" b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| 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VT promotes the expression of MDA5 and RIG-I as well as TLR3 </a:t>
            </a:r>
            <a:r>
              <a:rPr lang="en-US" altLang="ko-KR" sz="120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C57BL/6 mice (n=6 per group) were injected intramuscularly with 10 </a:t>
            </a:r>
            <a:r>
              <a:rPr lang="en-US" altLang="ko-K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poly(I:C), NVT, or CpG. After 5 h, total RNA was isolated from mouse inguinal lymph node and RT-PCR was performed for TLR3 (A), MDA-5 (B), and RIG-I ©. The mRNA level of target genes was normalized to the housekeeping gene HPRT and expressed as relative values to non-treated (NT) controls. *, </a:t>
            </a:r>
            <a:r>
              <a:rPr lang="en-US" altLang="ko-KR" sz="120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5; ns, not significant.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1283" y="1157622"/>
            <a:ext cx="7669433" cy="3493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697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282</TotalTime>
  <Words>509</Words>
  <Application>Microsoft Office PowerPoint</Application>
  <PresentationFormat>와이드스크린</PresentationFormat>
  <Paragraphs>11</Paragraphs>
  <Slides>4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Roboto</vt:lpstr>
      <vt:lpstr>맑은 고딕</vt:lpstr>
      <vt:lpstr>바탕체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AVI</dc:creator>
  <cp:lastModifiedBy>Seung Hyun Han</cp:lastModifiedBy>
  <cp:revision>1216</cp:revision>
  <cp:lastPrinted>2022-10-12T23:45:52Z</cp:lastPrinted>
  <dcterms:created xsi:type="dcterms:W3CDTF">2020-09-25T00:13:28Z</dcterms:created>
  <dcterms:modified xsi:type="dcterms:W3CDTF">2023-01-18T05:03:50Z</dcterms:modified>
</cp:coreProperties>
</file>